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19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\\ism\Tumor-Biology-Unit\NEW%20Shared%20including%20C9060%2022-4-21\Daniela\BC-ER-Macrophages%20paper\WB%20protein%20CM%20statistic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danielana\Desktop\Daniela\Experiments\%2301-21%20MCF7%20with%20CM%20from%20human%20macrophages%20(THP1)%20-%20protein%20+%20RNA\Protein\0121%200221%20WB%20quantit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4T1'!$N$29:$N$30</c:f>
                <c:numCache>
                  <c:formatCode>General</c:formatCode>
                  <c:ptCount val="2"/>
                  <c:pt idx="0">
                    <c:v>2.4720869608655834E-2</c:v>
                  </c:pt>
                  <c:pt idx="1">
                    <c:v>0.606564760655434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'4T1'!$L$29:$L$30</c:f>
              <c:strCache>
                <c:ptCount val="2"/>
                <c:pt idx="0">
                  <c:v>Cont</c:v>
                </c:pt>
                <c:pt idx="1">
                  <c:v>Mφ C16</c:v>
                </c:pt>
              </c:strCache>
            </c:strRef>
          </c:cat>
          <c:val>
            <c:numRef>
              <c:f>'4T1'!$M$29:$M$30</c:f>
              <c:numCache>
                <c:formatCode>General</c:formatCode>
                <c:ptCount val="2"/>
                <c:pt idx="0">
                  <c:v>1</c:v>
                </c:pt>
                <c:pt idx="1">
                  <c:v>4.07880692010252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9D-46AF-9278-5AF4A0EB9A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7"/>
        <c:axId val="392882904"/>
        <c:axId val="392882576"/>
      </c:barChart>
      <c:catAx>
        <c:axId val="392882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2882576"/>
        <c:crosses val="autoZero"/>
        <c:auto val="1"/>
        <c:lblAlgn val="ctr"/>
        <c:lblOffset val="1"/>
        <c:noMultiLvlLbl val="0"/>
      </c:catAx>
      <c:valAx>
        <c:axId val="392882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288290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D$47:$D$48</c:f>
              <c:strCache>
                <c:ptCount val="2"/>
                <c:pt idx="0">
                  <c:v>1</c:v>
                </c:pt>
                <c:pt idx="1">
                  <c:v>3.075806744</c:v>
                </c:pt>
              </c:strCache>
            </c:strRef>
          </c:tx>
          <c:spPr>
            <a:solidFill>
              <a:sysClr val="windowText" lastClr="0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47:$E$48</c:f>
                <c:numCache>
                  <c:formatCode>General</c:formatCode>
                  <c:ptCount val="2"/>
                  <c:pt idx="0">
                    <c:v>6.853133555508162E-3</c:v>
                  </c:pt>
                  <c:pt idx="1">
                    <c:v>5.996988039595894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Sheet1!$C$47:$C$48</c:f>
              <c:strCache>
                <c:ptCount val="2"/>
                <c:pt idx="0">
                  <c:v>Untreated</c:v>
                </c:pt>
                <c:pt idx="1">
                  <c:v>sFA</c:v>
                </c:pt>
              </c:strCache>
            </c:strRef>
          </c:cat>
          <c:val>
            <c:numRef>
              <c:f>Sheet1!$D$47:$D$48</c:f>
              <c:numCache>
                <c:formatCode>General</c:formatCode>
                <c:ptCount val="2"/>
                <c:pt idx="0">
                  <c:v>1</c:v>
                </c:pt>
                <c:pt idx="1">
                  <c:v>3.07580674431130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F4-40CF-80A1-188B8183EA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7"/>
        <c:axId val="136321648"/>
        <c:axId val="176892248"/>
      </c:barChart>
      <c:catAx>
        <c:axId val="136321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76892248"/>
        <c:crosses val="autoZero"/>
        <c:auto val="1"/>
        <c:lblAlgn val="ctr"/>
        <c:lblOffset val="1"/>
        <c:noMultiLvlLbl val="0"/>
      </c:catAx>
      <c:valAx>
        <c:axId val="1768922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632164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15908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58331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04167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29732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17722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06660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24876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72053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158416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71318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4925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086EB-BE77-466F-A3AC-E73E9E144271}" type="datetimeFigureOut">
              <a:rPr lang="he-IL" smtClean="0"/>
              <a:t>ט"ז/אלול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B9DB7-600F-4C1A-8FB0-D4896C99EC3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523818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819950" y="274012"/>
            <a:ext cx="317716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/>
              <a:t>B</a:t>
            </a:r>
            <a:endParaRPr lang="he-IL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EE84E9F-B629-4DDF-B13E-0F7C728F2276}"/>
              </a:ext>
            </a:extLst>
          </p:cNvPr>
          <p:cNvSpPr txBox="1"/>
          <p:nvPr/>
        </p:nvSpPr>
        <p:spPr>
          <a:xfrm>
            <a:off x="99193" y="267956"/>
            <a:ext cx="324128" cy="369332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b="1" dirty="0"/>
              <a:t>A</a:t>
            </a:r>
            <a:endParaRPr lang="he-IL" b="1" dirty="0"/>
          </a:p>
        </p:txBody>
      </p:sp>
      <p:sp>
        <p:nvSpPr>
          <p:cNvPr id="46" name="Rectangle 45"/>
          <p:cNvSpPr/>
          <p:nvPr/>
        </p:nvSpPr>
        <p:spPr>
          <a:xfrm rot="16200000">
            <a:off x="-825378" y="1837311"/>
            <a:ext cx="231641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 defTabSz="914400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ER</a:t>
            </a:r>
            <a:r>
              <a:rPr lang="el-GR" sz="12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 / GAPDH, relative intensity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CC969AF-32F5-4E3B-AD88-7F357F27CE9D}"/>
              </a:ext>
            </a:extLst>
          </p:cNvPr>
          <p:cNvSpPr txBox="1"/>
          <p:nvPr/>
        </p:nvSpPr>
        <p:spPr>
          <a:xfrm>
            <a:off x="4139233" y="1039920"/>
            <a:ext cx="364859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*</a:t>
            </a:r>
            <a:endParaRPr lang="he-IL" sz="1200" dirty="0"/>
          </a:p>
        </p:txBody>
      </p:sp>
      <p:sp>
        <p:nvSpPr>
          <p:cNvPr id="67" name="Rectangle 66"/>
          <p:cNvSpPr/>
          <p:nvPr/>
        </p:nvSpPr>
        <p:spPr>
          <a:xfrm rot="16200000">
            <a:off x="1951648" y="1854589"/>
            <a:ext cx="222221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 defTabSz="914400"/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ER</a:t>
            </a:r>
            <a:r>
              <a:rPr lang="el-GR" sz="1200" dirty="0">
                <a:solidFill>
                  <a:prstClr val="black"/>
                </a:solidFill>
                <a:cs typeface="Times New Roman" panose="02020603050405020304" pitchFamily="18" charset="0"/>
              </a:rPr>
              <a:t>α</a:t>
            </a:r>
            <a:r>
              <a:rPr lang="en-US" sz="1200" dirty="0">
                <a:solidFill>
                  <a:prstClr val="black"/>
                </a:solidFill>
                <a:cs typeface="Times New Roman" panose="02020603050405020304" pitchFamily="18" charset="0"/>
              </a:rPr>
              <a:t> / GAPDH, relative intensity</a:t>
            </a:r>
          </a:p>
        </p:txBody>
      </p:sp>
      <p:sp>
        <p:nvSpPr>
          <p:cNvPr id="68" name="Rectangle 67"/>
          <p:cNvSpPr/>
          <p:nvPr/>
        </p:nvSpPr>
        <p:spPr>
          <a:xfrm>
            <a:off x="0" y="7782371"/>
            <a:ext cx="6753411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2. A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4T1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urine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C cells were either remained untreated (Cont.) or incubated (24 h, 37°C) with medium conditioned by macrophages stimulated (16 h) by vehicle (BSA) alone (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·M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ϕ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or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F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almitic acid) conjugated with fatty acid free-BSA at a 2:1 molar ratio (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FA·M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ϕ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Human BC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CF-7 cells were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ither remained untreated (Cont.) or incubated (24 h, 37°C) with medium conditioned by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human macrophages derived from THP1 cells,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timulated (16 h) by BSA alone (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·hM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ϕ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or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F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almitic acid) conjugated with fatty acid free-BSA at a 2:1 molar ratio (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FA·hM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ϕ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. 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, B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rotein levels were determined by immunoblotting and band intensity was quantified using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ImageJ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oftware; intensity ratio for E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/GAPDH is shown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rror bars represent ±SD.*p&lt;0.03; **p&lt;0,0015. </a:t>
            </a:r>
            <a:endParaRPr lang="he-IL" sz="2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CC969AF-32F5-4E3B-AD88-7F357F27CE9D}"/>
              </a:ext>
            </a:extLst>
          </p:cNvPr>
          <p:cNvSpPr txBox="1"/>
          <p:nvPr/>
        </p:nvSpPr>
        <p:spPr>
          <a:xfrm>
            <a:off x="1351424" y="708720"/>
            <a:ext cx="364859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dirty="0"/>
              <a:t>*</a:t>
            </a:r>
            <a:endParaRPr lang="he-IL" sz="1200" dirty="0"/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19B70F48-6E4B-4B3F-8F61-B47F046A2615}"/>
              </a:ext>
            </a:extLst>
          </p:cNvPr>
          <p:cNvGraphicFramePr>
            <a:graphicFrameLocks/>
          </p:cNvGraphicFramePr>
          <p:nvPr/>
        </p:nvGraphicFramePr>
        <p:xfrm>
          <a:off x="435613" y="632450"/>
          <a:ext cx="1433138" cy="27568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3" name="Rectangle 62"/>
          <p:cNvSpPr/>
          <p:nvPr/>
        </p:nvSpPr>
        <p:spPr>
          <a:xfrm>
            <a:off x="780392" y="3104173"/>
            <a:ext cx="1023468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prstClr val="black"/>
                </a:solidFill>
              </a:rPr>
              <a:t>Cont.        </a:t>
            </a:r>
            <a:r>
              <a:rPr lang="en-US" sz="900" dirty="0" err="1">
                <a:solidFill>
                  <a:prstClr val="black"/>
                </a:solidFill>
              </a:rPr>
              <a:t>sFA·M</a:t>
            </a:r>
            <a:r>
              <a:rPr lang="el-GR" sz="900" dirty="0">
                <a:solidFill>
                  <a:prstClr val="black"/>
                </a:solidFill>
              </a:rPr>
              <a:t>φ</a:t>
            </a:r>
            <a:r>
              <a:rPr lang="en-US" sz="900" dirty="0">
                <a:solidFill>
                  <a:prstClr val="black"/>
                </a:solidFill>
              </a:rPr>
              <a:t>       </a:t>
            </a:r>
            <a:endParaRPr lang="he-IL" dirty="0"/>
          </a:p>
        </p:txBody>
      </p:sp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CD623415-4497-44E2-9440-5A9905FC7A54}"/>
              </a:ext>
            </a:extLst>
          </p:cNvPr>
          <p:cNvGraphicFramePr>
            <a:graphicFrameLocks/>
          </p:cNvGraphicFramePr>
          <p:nvPr/>
        </p:nvGraphicFramePr>
        <p:xfrm>
          <a:off x="3238081" y="632450"/>
          <a:ext cx="1441335" cy="26916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8" name="Rectangle 37"/>
          <p:cNvSpPr/>
          <p:nvPr/>
        </p:nvSpPr>
        <p:spPr>
          <a:xfrm>
            <a:off x="3580238" y="3104173"/>
            <a:ext cx="1090921" cy="230832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prstClr val="black"/>
                </a:solidFill>
              </a:rPr>
              <a:t>Cont.       </a:t>
            </a:r>
            <a:r>
              <a:rPr lang="en-US" sz="900" dirty="0" err="1">
                <a:solidFill>
                  <a:prstClr val="black"/>
                </a:solidFill>
              </a:rPr>
              <a:t>sFA·hM</a:t>
            </a:r>
            <a:r>
              <a:rPr lang="el-GR" sz="900" dirty="0">
                <a:solidFill>
                  <a:prstClr val="black"/>
                </a:solidFill>
              </a:rPr>
              <a:t>φ</a:t>
            </a:r>
            <a:r>
              <a:rPr lang="en-US" sz="900" dirty="0">
                <a:solidFill>
                  <a:prstClr val="black"/>
                </a:solidFill>
              </a:rPr>
              <a:t>       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3468081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19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דניאלה בלנק - DANIELA NAHMIAS BLANK</dc:creator>
  <cp:lastModifiedBy>MDPI-52</cp:lastModifiedBy>
  <cp:revision>5</cp:revision>
  <dcterms:created xsi:type="dcterms:W3CDTF">2022-07-13T06:55:11Z</dcterms:created>
  <dcterms:modified xsi:type="dcterms:W3CDTF">2022-09-12T11:27:11Z</dcterms:modified>
</cp:coreProperties>
</file>